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30" r:id="rId2"/>
  </p:sldIdLst>
  <p:sldSz cx="9144000" cy="6858000" type="screen4x3"/>
  <p:notesSz cx="7010400" cy="92964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CC"/>
    <a:srgbClr val="FF9999"/>
    <a:srgbClr val="5CA0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050" autoAdjust="0"/>
    <p:restoredTop sz="87515" autoAdjust="0"/>
  </p:normalViewPr>
  <p:slideViewPr>
    <p:cSldViewPr snapToGrid="0" snapToObjects="1">
      <p:cViewPr>
        <p:scale>
          <a:sx n="90" d="100"/>
          <a:sy n="90" d="100"/>
        </p:scale>
        <p:origin x="-1650" y="-2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esults!$D$6</c:f>
              <c:strCache>
                <c:ptCount val="1"/>
                <c:pt idx="0">
                  <c:v>WT-SOX9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Results!$I$15:$K$15</c:f>
                <c:numCache>
                  <c:formatCode>General</c:formatCode>
                  <c:ptCount val="3"/>
                  <c:pt idx="0">
                    <c:v>3.0683904554849799</c:v>
                  </c:pt>
                  <c:pt idx="1">
                    <c:v>0.35088704005957999</c:v>
                  </c:pt>
                  <c:pt idx="2">
                    <c:v>0.432101111680576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Results!$E$5:$G$5</c:f>
              <c:strCache>
                <c:ptCount val="3"/>
                <c:pt idx="0">
                  <c:v>CCNB1</c:v>
                </c:pt>
                <c:pt idx="1">
                  <c:v>CCNB2</c:v>
                </c:pt>
                <c:pt idx="2">
                  <c:v>TOP2A</c:v>
                </c:pt>
              </c:strCache>
            </c:strRef>
          </c:cat>
          <c:val>
            <c:numRef>
              <c:f>Results!$E$6:$G$6</c:f>
              <c:numCache>
                <c:formatCode>General</c:formatCode>
                <c:ptCount val="3"/>
                <c:pt idx="0">
                  <c:v>12.813530133280265</c:v>
                </c:pt>
                <c:pt idx="1">
                  <c:v>1.8798903136580614</c:v>
                </c:pt>
                <c:pt idx="2">
                  <c:v>2.1402883319136934</c:v>
                </c:pt>
              </c:numCache>
            </c:numRef>
          </c:val>
        </c:ser>
        <c:ser>
          <c:idx val="1"/>
          <c:order val="1"/>
          <c:tx>
            <c:strRef>
              <c:f>Results!$D$7</c:f>
              <c:strCache>
                <c:ptCount val="1"/>
                <c:pt idx="0">
                  <c:v>SOX9ΔHMG-NLS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Results!$I$16:$K$16</c:f>
                <c:numCache>
                  <c:formatCode>General</c:formatCode>
                  <c:ptCount val="3"/>
                  <c:pt idx="0">
                    <c:v>1.7966458448262221</c:v>
                  </c:pt>
                  <c:pt idx="1">
                    <c:v>0.47517420475608579</c:v>
                  </c:pt>
                  <c:pt idx="2">
                    <c:v>0.389418183588553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Results!$E$5:$G$5</c:f>
              <c:strCache>
                <c:ptCount val="3"/>
                <c:pt idx="0">
                  <c:v>CCNB1</c:v>
                </c:pt>
                <c:pt idx="1">
                  <c:v>CCNB2</c:v>
                </c:pt>
                <c:pt idx="2">
                  <c:v>TOP2A</c:v>
                </c:pt>
              </c:strCache>
            </c:strRef>
          </c:cat>
          <c:val>
            <c:numRef>
              <c:f>Results!$E$7:$G$7</c:f>
              <c:numCache>
                <c:formatCode>General</c:formatCode>
                <c:ptCount val="3"/>
                <c:pt idx="0">
                  <c:v>18.229792797184</c:v>
                </c:pt>
                <c:pt idx="1">
                  <c:v>1.9938804451664758</c:v>
                </c:pt>
                <c:pt idx="2">
                  <c:v>2.826330382404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8073728"/>
        <c:axId val="68075520"/>
      </c:barChart>
      <c:catAx>
        <c:axId val="68073728"/>
        <c:scaling>
          <c:orientation val="minMax"/>
        </c:scaling>
        <c:delete val="0"/>
        <c:axPos val="b"/>
        <c:majorTickMark val="out"/>
        <c:minorTickMark val="none"/>
        <c:tickLblPos val="nextTo"/>
        <c:crossAx val="68075520"/>
        <c:crosses val="autoZero"/>
        <c:auto val="1"/>
        <c:lblAlgn val="ctr"/>
        <c:lblOffset val="100"/>
        <c:noMultiLvlLbl val="0"/>
      </c:catAx>
      <c:valAx>
        <c:axId val="680755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68073728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1B45C1-70C3-46D4-A32A-FEF0581B8A5B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pPr lvl="0"/>
            <a:endParaRPr 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altLang="en-US" smtClean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197D4DD6-878A-4260-A1E7-ACE1E5C6D78E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117745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3EAE41D-2269-4843-8591-71C50AAC54BE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DDE7CE2-2D80-40F5-ABAC-8DE69FF83D39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44653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39B5717-CCCB-4FCC-B6DE-385F92E03DA6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ADEAB87-A5B5-44D2-8973-06B1501D6E7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59841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70D7AE9-D5BB-4A40-92F2-1A42C23B9134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7AD86FC-0FFD-437C-A4A1-AD4734B614C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2226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9AD9D0F-96BD-45CF-98FC-244FD5D9E65A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AAB62F0-F8E4-48F3-BEFD-4A18B9EB52E7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61588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DAA410-CDC7-4019-A096-24A8B774AE40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E0B0FEA-C3B0-4788-9007-28C3C6A2343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844020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E92A3EB-8E61-4E4D-9D10-C62C6723DAFA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A99C0D-0EEF-4CC2-8A8B-BCAA9A67A1E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27628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B5F3BEC-C0FB-49C7-8277-2CCE1C67C53A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811DA4F-9054-46D9-805D-342878FF837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52543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4560479-DC70-46D5-AB77-FF9A6C1DDE94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D43EBC1-E17E-4201-A773-5D61902CA3E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6143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9C22A94-A4ED-47F0-B336-47B01763B61B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57B61B1-0937-446C-A80A-89B6E80C866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16877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D44B365-877C-40C4-AA09-1F761367865E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B3C69BA-C42F-4B47-A7DC-D122A2062860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48573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D234A69-B555-4775-91C3-908FFDC622B8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AB703BB-9289-49B9-BB2D-7ED69C5982C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334694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512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2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fld id="{ED3AAABA-8377-4DC6-85F9-8CCA4D29B76F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fld id="{7098F2EA-2152-4D8B-AE61-139F6DDF9A3D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chart" Target="../charts/chart1.xml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>
            <a:grpSpLocks/>
          </p:cNvGrpSpPr>
          <p:nvPr/>
        </p:nvGrpSpPr>
        <p:grpSpPr bwMode="auto">
          <a:xfrm>
            <a:off x="234240" y="21354"/>
            <a:ext cx="3531752" cy="3408440"/>
            <a:chOff x="5856949" y="1425893"/>
            <a:chExt cx="3154596" cy="2693973"/>
          </a:xfrm>
        </p:grpSpPr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68062" y="2804435"/>
              <a:ext cx="2083106" cy="884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56949" y="3792411"/>
              <a:ext cx="2098170" cy="3274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TextBox 70"/>
            <p:cNvSpPr txBox="1">
              <a:spLocks noChangeArrowheads="1"/>
            </p:cNvSpPr>
            <p:nvPr/>
          </p:nvSpPr>
          <p:spPr bwMode="auto">
            <a:xfrm>
              <a:off x="7955121" y="3092664"/>
              <a:ext cx="828675" cy="2189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200" dirty="0" smtClean="0"/>
                <a:t>FLAG</a:t>
              </a:r>
              <a:endParaRPr lang="en-US" altLang="en-US" sz="1200" dirty="0"/>
            </a:p>
          </p:txBody>
        </p:sp>
        <p:sp>
          <p:nvSpPr>
            <p:cNvPr id="7" name="TextBox 71"/>
            <p:cNvSpPr txBox="1">
              <a:spLocks noChangeArrowheads="1"/>
            </p:cNvSpPr>
            <p:nvPr/>
          </p:nvSpPr>
          <p:spPr bwMode="auto">
            <a:xfrm>
              <a:off x="7955118" y="3802250"/>
              <a:ext cx="1056427" cy="2189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200" dirty="0" smtClean="0">
                  <a:latin typeface="Symbol" pitchFamily="18" charset="2"/>
                </a:rPr>
                <a:t>b</a:t>
              </a:r>
              <a:r>
                <a:rPr lang="en-US" altLang="en-US" sz="1200" dirty="0" smtClean="0"/>
                <a:t> </a:t>
              </a:r>
              <a:r>
                <a:rPr lang="en-US" altLang="en-US" sz="1200" dirty="0"/>
                <a:t>actin</a:t>
              </a:r>
            </a:p>
          </p:txBody>
        </p:sp>
        <p:sp>
          <p:nvSpPr>
            <p:cNvPr id="8" name="TextBox 72"/>
            <p:cNvSpPr txBox="1">
              <a:spLocks noChangeArrowheads="1"/>
            </p:cNvSpPr>
            <p:nvPr/>
          </p:nvSpPr>
          <p:spPr bwMode="auto">
            <a:xfrm rot="18834123">
              <a:off x="5935521" y="2321839"/>
              <a:ext cx="927018" cy="2474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200" dirty="0"/>
                <a:t>control</a:t>
              </a:r>
            </a:p>
          </p:txBody>
        </p:sp>
        <p:sp>
          <p:nvSpPr>
            <p:cNvPr id="9" name="TextBox 73"/>
            <p:cNvSpPr txBox="1">
              <a:spLocks noChangeArrowheads="1"/>
            </p:cNvSpPr>
            <p:nvPr/>
          </p:nvSpPr>
          <p:spPr bwMode="auto">
            <a:xfrm rot="18834123">
              <a:off x="6312833" y="2078314"/>
              <a:ext cx="1546396" cy="2474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200" dirty="0" smtClean="0"/>
                <a:t>FLAG- </a:t>
              </a:r>
              <a:r>
                <a:rPr lang="en-US" altLang="en-US" sz="1200" dirty="0"/>
                <a:t>WT SOX9</a:t>
              </a:r>
            </a:p>
          </p:txBody>
        </p:sp>
        <p:sp>
          <p:nvSpPr>
            <p:cNvPr id="10" name="TextBox 74"/>
            <p:cNvSpPr txBox="1">
              <a:spLocks noChangeArrowheads="1"/>
            </p:cNvSpPr>
            <p:nvPr/>
          </p:nvSpPr>
          <p:spPr bwMode="auto">
            <a:xfrm rot="18834123">
              <a:off x="6713794" y="2192335"/>
              <a:ext cx="1289907" cy="2474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200" dirty="0" smtClean="0"/>
                <a:t>FLAG-SOX9</a:t>
              </a:r>
              <a:r>
                <a:rPr lang="el-GR" altLang="en-US" sz="1200" dirty="0"/>
                <a:t>Δ</a:t>
              </a:r>
              <a:r>
                <a:rPr lang="en-US" altLang="en-US" sz="1200" dirty="0"/>
                <a:t>HMG</a:t>
              </a:r>
            </a:p>
          </p:txBody>
        </p:sp>
        <p:sp>
          <p:nvSpPr>
            <p:cNvPr id="11" name="TextBox 75"/>
            <p:cNvSpPr txBox="1">
              <a:spLocks noChangeArrowheads="1"/>
            </p:cNvSpPr>
            <p:nvPr/>
          </p:nvSpPr>
          <p:spPr bwMode="auto">
            <a:xfrm rot="18834123">
              <a:off x="7070873" y="2095137"/>
              <a:ext cx="1585905" cy="2474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200" dirty="0" smtClean="0"/>
                <a:t>FLAG-SOX9</a:t>
              </a:r>
              <a:r>
                <a:rPr lang="el-GR" altLang="en-US" sz="1200" dirty="0"/>
                <a:t>Δ</a:t>
              </a:r>
              <a:r>
                <a:rPr lang="en-US" altLang="en-US" sz="1200" dirty="0"/>
                <a:t>HMG-NLS</a:t>
              </a:r>
            </a:p>
          </p:txBody>
        </p:sp>
        <p:sp>
          <p:nvSpPr>
            <p:cNvPr id="12" name="TextBox 76"/>
            <p:cNvSpPr txBox="1">
              <a:spLocks noChangeArrowheads="1"/>
            </p:cNvSpPr>
            <p:nvPr/>
          </p:nvSpPr>
          <p:spPr bwMode="auto">
            <a:xfrm rot="18834123">
              <a:off x="7496648" y="2192989"/>
              <a:ext cx="1348891" cy="2474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200" dirty="0" smtClean="0"/>
                <a:t>FLAG-SOX9-303 </a:t>
              </a:r>
              <a:r>
                <a:rPr lang="el-GR" altLang="en-US" sz="1200" dirty="0"/>
                <a:t>Δ</a:t>
              </a:r>
              <a:r>
                <a:rPr lang="en-US" altLang="en-US" sz="1200" dirty="0"/>
                <a:t>C</a:t>
              </a:r>
            </a:p>
          </p:txBody>
        </p:sp>
      </p:grpSp>
      <p:pic>
        <p:nvPicPr>
          <p:cNvPr id="14" name="Picture 5" descr="H:\4-04-2014 HCT116 HMG NLS, 303\overexpression of flag SOX9 HMG NLS-13, anti flag, anti YA\Captured TRITC2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231" t="38380" r="33528" b="21790"/>
          <a:stretch/>
        </p:blipFill>
        <p:spPr bwMode="auto">
          <a:xfrm rot="16200000">
            <a:off x="5588410" y="1818433"/>
            <a:ext cx="1131463" cy="14329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6" descr="H:\4-04-2014 HCT116 HMG NLS, 303\overexpression of flag SOX9 HMG NLS-13, anti flag, anti YA\Captured DAPI2 T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231" t="38380" r="33528" b="21788"/>
          <a:stretch/>
        </p:blipFill>
        <p:spPr bwMode="auto">
          <a:xfrm rot="16200000">
            <a:off x="5588410" y="611841"/>
            <a:ext cx="1131461" cy="1432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7" descr="H:\4-04-2014 HCT116 HMG NLS, 303\overexpression of flag SOX9 HMG NLS-13, anti flag, anti YA\Captured DAPI2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231" t="38380" r="33527" b="21788"/>
          <a:stretch/>
        </p:blipFill>
        <p:spPr bwMode="auto">
          <a:xfrm rot="16200000">
            <a:off x="5588409" y="3030714"/>
            <a:ext cx="1131462" cy="1432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Box 7"/>
          <p:cNvSpPr txBox="1">
            <a:spLocks noChangeArrowheads="1"/>
          </p:cNvSpPr>
          <p:nvPr/>
        </p:nvSpPr>
        <p:spPr bwMode="auto">
          <a:xfrm rot="16200000">
            <a:off x="3277093" y="1158771"/>
            <a:ext cx="9625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1200" dirty="0" smtClean="0">
                <a:solidFill>
                  <a:srgbClr val="00B0F0"/>
                </a:solidFill>
              </a:rPr>
              <a:t>DAPI</a:t>
            </a:r>
            <a:r>
              <a:rPr lang="en-US" altLang="en-US" sz="1200" dirty="0" smtClean="0"/>
              <a:t>/</a:t>
            </a:r>
            <a:r>
              <a:rPr lang="en-US" altLang="en-US" sz="1200" dirty="0" smtClean="0">
                <a:solidFill>
                  <a:srgbClr val="FF0000"/>
                </a:solidFill>
              </a:rPr>
              <a:t>FLAG</a:t>
            </a:r>
            <a:endParaRPr lang="en-US" altLang="en-US" sz="1200" dirty="0">
              <a:solidFill>
                <a:srgbClr val="FF0000"/>
              </a:solidFill>
            </a:endParaRPr>
          </a:p>
        </p:txBody>
      </p:sp>
      <p:sp>
        <p:nvSpPr>
          <p:cNvPr id="18" name="TextBox 9"/>
          <p:cNvSpPr txBox="1">
            <a:spLocks noChangeArrowheads="1"/>
          </p:cNvSpPr>
          <p:nvPr/>
        </p:nvSpPr>
        <p:spPr bwMode="auto">
          <a:xfrm rot="16200000">
            <a:off x="3502910" y="3608682"/>
            <a:ext cx="53795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1200" dirty="0">
                <a:solidFill>
                  <a:srgbClr val="00B0F0"/>
                </a:solidFill>
              </a:rPr>
              <a:t>DAPI</a:t>
            </a:r>
          </a:p>
        </p:txBody>
      </p:sp>
      <p:sp>
        <p:nvSpPr>
          <p:cNvPr id="19" name="TextBox 10"/>
          <p:cNvSpPr txBox="1">
            <a:spLocks noChangeArrowheads="1"/>
          </p:cNvSpPr>
          <p:nvPr/>
        </p:nvSpPr>
        <p:spPr bwMode="auto">
          <a:xfrm rot="16200000">
            <a:off x="3460987" y="2307665"/>
            <a:ext cx="6319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1200" dirty="0" smtClean="0">
                <a:solidFill>
                  <a:srgbClr val="FF0000"/>
                </a:solidFill>
              </a:rPr>
              <a:t>FLAG</a:t>
            </a:r>
            <a:endParaRPr lang="en-US" altLang="en-US" sz="1200" dirty="0">
              <a:solidFill>
                <a:srgbClr val="FF0000"/>
              </a:solidFill>
            </a:endParaRPr>
          </a:p>
        </p:txBody>
      </p:sp>
      <p:pic>
        <p:nvPicPr>
          <p:cNvPr id="20" name="Picture 2" descr="H:\3-31-2014 HCT116, SOX9 303, HMG, Vim\SOX9 HMG\Captured DAPI1 T.jp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94" t="14774" r="16360" b="40198"/>
          <a:stretch/>
        </p:blipFill>
        <p:spPr bwMode="auto">
          <a:xfrm>
            <a:off x="3894616" y="762579"/>
            <a:ext cx="1434058" cy="11351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3" descr="H:\3-31-2014 HCT116, SOX9 303, HMG, Vim\SOX9 HMG\Captured DAPI1.jpg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94" t="14774" r="16360" b="40198"/>
          <a:stretch/>
        </p:blipFill>
        <p:spPr bwMode="auto">
          <a:xfrm>
            <a:off x="3894616" y="3177798"/>
            <a:ext cx="1432939" cy="11351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5" descr="H:\3-31-2014 HCT116, SOX9 303, HMG, Vim\SOX9 HMG\Captured TRITC1.jpg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94" t="14774" r="16360" b="40198"/>
          <a:stretch/>
        </p:blipFill>
        <p:spPr bwMode="auto">
          <a:xfrm>
            <a:off x="3894616" y="1959518"/>
            <a:ext cx="1441797" cy="11351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" name="TextBox 19"/>
          <p:cNvSpPr txBox="1">
            <a:spLocks noChangeArrowheads="1"/>
          </p:cNvSpPr>
          <p:nvPr/>
        </p:nvSpPr>
        <p:spPr bwMode="auto">
          <a:xfrm>
            <a:off x="5372356" y="463591"/>
            <a:ext cx="17097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1200" dirty="0" smtClean="0"/>
              <a:t>FLAG-SOX9</a:t>
            </a:r>
            <a:r>
              <a:rPr lang="el-GR" altLang="en-US" sz="1200" dirty="0"/>
              <a:t>Δ</a:t>
            </a:r>
            <a:r>
              <a:rPr lang="en-US" altLang="en-US" sz="1200" dirty="0"/>
              <a:t>HMG-NLS </a:t>
            </a:r>
          </a:p>
        </p:txBody>
      </p:sp>
      <p:sp>
        <p:nvSpPr>
          <p:cNvPr id="24" name="TextBox 20"/>
          <p:cNvSpPr txBox="1">
            <a:spLocks noChangeArrowheads="1"/>
          </p:cNvSpPr>
          <p:nvPr/>
        </p:nvSpPr>
        <p:spPr bwMode="auto">
          <a:xfrm>
            <a:off x="3894616" y="463592"/>
            <a:ext cx="143405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1200" dirty="0" smtClean="0"/>
              <a:t>FLAG-SOX9</a:t>
            </a:r>
            <a:r>
              <a:rPr lang="el-GR" altLang="en-US" sz="1200" dirty="0"/>
              <a:t>Δ</a:t>
            </a:r>
            <a:r>
              <a:rPr lang="en-US" altLang="en-US" sz="1200" dirty="0"/>
              <a:t>HMG </a:t>
            </a:r>
          </a:p>
        </p:txBody>
      </p:sp>
      <p:pic>
        <p:nvPicPr>
          <p:cNvPr id="25" name="Picture 2" descr="H:\3-31-2014 HCT116, SOX9 303, HMG, Vim\SOX9 303\Captured DAPI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33" t="7893" r="47144" b="47929"/>
          <a:stretch>
            <a:fillRect/>
          </a:stretch>
        </p:blipFill>
        <p:spPr bwMode="auto">
          <a:xfrm rot="16200000">
            <a:off x="7094556" y="3057512"/>
            <a:ext cx="1135121" cy="1382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4" descr="H:\3-31-2014 HCT116, SOX9 303, HMG, Vim\SOX9 303\Captured TRITC D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33" t="7893" r="47144" b="47929"/>
          <a:stretch>
            <a:fillRect/>
          </a:stretch>
        </p:blipFill>
        <p:spPr bwMode="auto">
          <a:xfrm rot="16200000">
            <a:off x="7094558" y="638637"/>
            <a:ext cx="1135117" cy="1382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" name="Picture 5" descr="H:\3-31-2014 HCT116, SOX9 303, HMG, Vim\SOX9 303\Captured TRITC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34" t="7893" r="47144" b="47929"/>
          <a:stretch>
            <a:fillRect/>
          </a:stretch>
        </p:blipFill>
        <p:spPr bwMode="auto">
          <a:xfrm rot="16200000">
            <a:off x="7096385" y="1843402"/>
            <a:ext cx="1131464" cy="1382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" name="TextBox 25"/>
          <p:cNvSpPr txBox="1">
            <a:spLocks noChangeArrowheads="1"/>
          </p:cNvSpPr>
          <p:nvPr/>
        </p:nvSpPr>
        <p:spPr bwMode="auto">
          <a:xfrm>
            <a:off x="6970617" y="448420"/>
            <a:ext cx="152454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altLang="en-US" sz="1200" dirty="0" smtClean="0"/>
              <a:t>FLAG-SOX9-303 </a:t>
            </a:r>
            <a:r>
              <a:rPr lang="el-GR" altLang="en-US" sz="1200" dirty="0"/>
              <a:t>Δ</a:t>
            </a:r>
            <a:r>
              <a:rPr lang="en-US" altLang="en-US" sz="1200" dirty="0"/>
              <a:t>C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34240" y="577913"/>
            <a:ext cx="719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9" name="TextBox 28"/>
          <p:cNvSpPr txBox="1"/>
          <p:nvPr/>
        </p:nvSpPr>
        <p:spPr>
          <a:xfrm>
            <a:off x="3806623" y="68202"/>
            <a:ext cx="719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30" name="TextBox 29"/>
          <p:cNvSpPr txBox="1"/>
          <p:nvPr/>
        </p:nvSpPr>
        <p:spPr>
          <a:xfrm>
            <a:off x="4166438" y="48532"/>
            <a:ext cx="15318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CT116</a:t>
            </a:r>
            <a:endParaRPr lang="en-US" sz="1400" dirty="0"/>
          </a:p>
        </p:txBody>
      </p:sp>
      <p:sp>
        <p:nvSpPr>
          <p:cNvPr id="31" name="TextBox 30"/>
          <p:cNvSpPr txBox="1"/>
          <p:nvPr/>
        </p:nvSpPr>
        <p:spPr>
          <a:xfrm>
            <a:off x="515945" y="638960"/>
            <a:ext cx="15318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HCT116</a:t>
            </a:r>
            <a:endParaRPr lang="en-US" sz="1400" dirty="0"/>
          </a:p>
        </p:txBody>
      </p:sp>
      <p:sp>
        <p:nvSpPr>
          <p:cNvPr id="35" name="TextBox 34"/>
          <p:cNvSpPr txBox="1"/>
          <p:nvPr/>
        </p:nvSpPr>
        <p:spPr>
          <a:xfrm>
            <a:off x="528920" y="4131906"/>
            <a:ext cx="4939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274613" y="5136015"/>
            <a:ext cx="9893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% of input</a:t>
            </a:r>
            <a:endParaRPr lang="en-US" sz="1400" dirty="0"/>
          </a:p>
        </p:txBody>
      </p:sp>
      <p:sp>
        <p:nvSpPr>
          <p:cNvPr id="38" name="TextBox 37"/>
          <p:cNvSpPr txBox="1"/>
          <p:nvPr/>
        </p:nvSpPr>
        <p:spPr>
          <a:xfrm>
            <a:off x="6329333" y="6131958"/>
            <a:ext cx="26231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9</a:t>
            </a:r>
            <a:endParaRPr lang="en-US" dirty="0"/>
          </a:p>
        </p:txBody>
      </p:sp>
      <p:graphicFrame>
        <p:nvGraphicFramePr>
          <p:cNvPr id="39" name="Chart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9334845"/>
              </p:ext>
            </p:extLst>
          </p:nvPr>
        </p:nvGraphicFramePr>
        <p:xfrm>
          <a:off x="832125" y="3961013"/>
          <a:ext cx="2484106" cy="25615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</p:spTree>
    <p:extLst>
      <p:ext uri="{BB962C8B-B14F-4D97-AF65-F5344CB8AC3E}">
        <p14:creationId xmlns:p14="http://schemas.microsoft.com/office/powerpoint/2010/main" val="27474611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051</TotalTime>
  <Words>39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enpathwa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ME runs</dc:title>
  <dc:creator>Paul Labhart</dc:creator>
  <cp:lastModifiedBy>Shi, Zhongcheng</cp:lastModifiedBy>
  <cp:revision>1582</cp:revision>
  <cp:lastPrinted>2014-02-08T00:35:07Z</cp:lastPrinted>
  <dcterms:created xsi:type="dcterms:W3CDTF">2013-01-30T00:52:15Z</dcterms:created>
  <dcterms:modified xsi:type="dcterms:W3CDTF">2015-05-08T18:54:18Z</dcterms:modified>
</cp:coreProperties>
</file>